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0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9628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164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3925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035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7978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052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516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843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1421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650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380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BFCB2-0706-452E-87E4-A0DEA877D589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E967C1-B865-43C2-9476-1D314808B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138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3"/>
          <p:cNvSpPr txBox="1">
            <a:spLocks/>
          </p:cNvSpPr>
          <p:nvPr/>
        </p:nvSpPr>
        <p:spPr>
          <a:xfrm>
            <a:off x="127000" y="5181600"/>
            <a:ext cx="8813800" cy="685800"/>
          </a:xfrm>
          <a:prstGeom prst="rect">
            <a:avLst/>
          </a:prstGeom>
        </p:spPr>
        <p:txBody>
          <a:bodyPr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mptoms of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mato leaf curl Sudan viru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oLCSDV) in virus-infected tomato plants. The tomato cultivar,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18 (Ali Mahjoub, KAUST, Thuwal, Saudi Arabia),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used for inoculation experiments.  Treatments were: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oLCSDV-inoculated,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ock-inoculated plant. Wild type accession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042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li Mahjoub, KAUST, Thuwal, Saudi Arabia)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oLCSDV-inoculated plant, and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ock-inoculated plant.</a:t>
            </a: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745" y="1445623"/>
            <a:ext cx="4438650" cy="3067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9090" y="1445623"/>
            <a:ext cx="4371975" cy="3067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46984" y="412219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620000" y="412219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2590800" y="412219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5791200" y="412219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69605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3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 M Idris</dc:creator>
  <cp:lastModifiedBy>Ali M Idris</cp:lastModifiedBy>
  <cp:revision>1</cp:revision>
  <dcterms:created xsi:type="dcterms:W3CDTF">2014-04-18T13:35:49Z</dcterms:created>
  <dcterms:modified xsi:type="dcterms:W3CDTF">2014-04-18T13:36:22Z</dcterms:modified>
</cp:coreProperties>
</file>